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oulanger, Lisa M." initials="LMB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2463" autoAdjust="0"/>
    <p:restoredTop sz="89146" autoAdjust="0"/>
  </p:normalViewPr>
  <p:slideViewPr>
    <p:cSldViewPr showGuides="1">
      <p:cViewPr>
        <p:scale>
          <a:sx n="75" d="100"/>
          <a:sy n="75" d="100"/>
        </p:scale>
        <p:origin x="-1512" y="-72"/>
      </p:cViewPr>
      <p:guideLst>
        <p:guide orient="horz" pos="1767"/>
        <p:guide pos="2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9327138" cy="3932713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03310D-168A-4725-986A-1DF8C00AC50E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40FE85-6C64-46EA-8FBB-1A01C2F08E7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6236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mtClean="0"/>
              <a:t>Figure S4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7C2CDE-7128-3E47-90AE-CFB30689CDF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295378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79348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8035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55376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79902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56586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5915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48147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77732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01818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12892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6811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87488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microsoft.com/office/2007/relationships/hdphoto" Target="../media/hdphoto1.wdp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6042" y="190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504146730"/>
              </p:ext>
            </p:extLst>
          </p:nvPr>
        </p:nvGraphicFramePr>
        <p:xfrm>
          <a:off x="105847" y="148847"/>
          <a:ext cx="6856413" cy="2447389"/>
        </p:xfrm>
        <a:graphic>
          <a:graphicData uri="http://schemas.openxmlformats.org/drawingml/2006/table">
            <a:tbl>
              <a:tblPr/>
              <a:tblGrid>
                <a:gridCol w="619125"/>
                <a:gridCol w="796773"/>
                <a:gridCol w="2641752"/>
                <a:gridCol w="2798763"/>
              </a:tblGrid>
              <a:tr h="269523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u="none" dirty="0"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Vector</a:t>
                      </a:r>
                      <a:endParaRPr lang="en-US" sz="800" u="none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u="none" dirty="0" smtClean="0"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Gene</a:t>
                      </a:r>
                      <a:endParaRPr lang="en-US" sz="800" u="none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u="none" dirty="0" smtClean="0"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Forward primer</a:t>
                      </a:r>
                      <a:endParaRPr lang="en-US" sz="800" u="none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u="none" dirty="0" smtClean="0"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everse primer</a:t>
                      </a:r>
                      <a:endParaRPr lang="en-US" sz="800" u="none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97">
                <a:tc rowSpan="6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ET29a (6xHis tag)</a:t>
                      </a: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2-K</a:t>
                      </a:r>
                      <a:endParaRPr lang="en-US" sz="8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CTAGATCTGAAGATGAGAAGGAGAAACACAGCT-3'</a:t>
                      </a:r>
                      <a:endParaRPr lang="en-US" sz="800" dirty="0"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AGCCATGGTCACGCTAGAGAATGCGGGTCATG-3'</a:t>
                      </a:r>
                      <a:endParaRPr lang="en-US" sz="800" dirty="0"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79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2-D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CTAGATCTGAAGAGAAGGAGAAACACAGGTGG-3'</a:t>
                      </a:r>
                      <a:endParaRPr lang="en-US" sz="800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AGCCATGGTCACGCTTTACAATCTCGGAGAGACAT-3'</a:t>
                      </a:r>
                      <a:endParaRPr lang="en-US" sz="800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27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2-T22</a:t>
                      </a:r>
                      <a:endParaRPr lang="en-US" sz="8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CTAGATCTGAAGAAGAATGCAGGTGGGAGAG-3'</a:t>
                      </a:r>
                      <a:endParaRPr lang="en-US" sz="800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AGCCATGGTCAAGGTGACAGTAAAGACTC-3'</a:t>
                      </a:r>
                      <a:endParaRPr lang="en-US" sz="800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276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H2-T23</a:t>
                      </a: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AGATCTGAAGAGGAGGAGACACA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-3'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tabLst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CCATGGTCATGCCTTCT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-3'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7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2-K T329A</a:t>
                      </a:r>
                      <a:endParaRPr lang="en-US" sz="8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cap="all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GGCTCCCAGGCGTCTGATCTGTCTCT-3'</a:t>
                      </a: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cap="all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AGACGCCTGGGAGCCTGGAGCCAGA-3'</a:t>
                      </a: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6054">
                <a:tc vMerge="1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solidFill>
                          <a:srgbClr val="FF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5564">
                <a:tc row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GTK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GST tag)</a:t>
                      </a: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2-K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cap="all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</a:t>
                      </a:r>
                      <a:r>
                        <a:rPr lang="en-US" sz="800" cap="all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CTGGATCCAAGATGAGAAGGAGAAACACAGCT-3</a:t>
                      </a:r>
                      <a:r>
                        <a:rPr lang="en-US" sz="800" cap="all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'</a:t>
                      </a: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cap="all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TATAAGCTTTCACGCTAGAGAATGAGGGTCATGAAC-3'</a:t>
                      </a: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48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H2-D</a:t>
                      </a: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cap="all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CTAGATCTGAAGATGAGAAGGAGAAACACAGCT-3'</a:t>
                      </a:r>
                      <a:endParaRPr lang="en-US" sz="800" cap="all" dirty="0" smtClean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cap="all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AGCCATGGTCACGCTAGAGAATGCGGGTCATG-3'</a:t>
                      </a:r>
                      <a:endParaRPr lang="en-US" sz="800" cap="all" dirty="0" smtClean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70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H2-T22</a:t>
                      </a: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5'-CTGGATCCAAGAAGAATGCAGGTGGGAGAG-3'</a:t>
                      </a: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5'-TATAAGCTTTCAAGGTGACAGTAAAGACTCGCC-3'</a:t>
                      </a: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146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H2-T23</a:t>
                      </a: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cap="all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GATCCAAGAGGAGGAGACACATA</a:t>
                      </a:r>
                      <a:r>
                        <a:rPr lang="en-US" sz="800" cap="all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-3'</a:t>
                      </a:r>
                      <a:endParaRPr lang="en-US" sz="800" cap="all" dirty="0" smtClean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cap="all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TAAGCTTTCATGCCTTCTGAGG</a:t>
                      </a:r>
                      <a:r>
                        <a:rPr lang="en-US" sz="800" cap="all" dirty="0" smtClean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-3'</a:t>
                      </a:r>
                      <a:endParaRPr lang="en-US" sz="800" cap="all" dirty="0" smtClean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27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2-K T329A</a:t>
                      </a:r>
                      <a:endParaRPr lang="en-US" sz="8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cap="all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CTGGATCCAAGATGAGAAGGAGAAACACAGCT-3'</a:t>
                      </a: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cap="all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ea typeface="Times New Roman"/>
                          <a:cs typeface="Courier New" panose="02070309020205020404" pitchFamily="49" charset="0"/>
                        </a:rPr>
                        <a:t>5'-TATAAGCTTTCACGCTAGAGAATGAGGGTCATGAAC-3'</a:t>
                      </a:r>
                      <a:endParaRPr lang="en-US" sz="800" cap="all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ea typeface="Calibri"/>
                        <a:cs typeface="Courier New" panose="02070309020205020404" pitchFamily="49" charset="0"/>
                      </a:endParaRPr>
                    </a:p>
                  </a:txBody>
                  <a:tcPr marL="30119" marR="301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6007073" y="889480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-20827" y="52078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79790" y="2717259"/>
            <a:ext cx="3117158" cy="2359418"/>
            <a:chOff x="3515294" y="3209379"/>
            <a:chExt cx="3168184" cy="1671309"/>
          </a:xfrm>
        </p:grpSpPr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15294" y="3209379"/>
              <a:ext cx="3168184" cy="1671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5" name="TextBox 84"/>
            <p:cNvSpPr txBox="1"/>
            <p:nvPr/>
          </p:nvSpPr>
          <p:spPr>
            <a:xfrm>
              <a:off x="3823783" y="3530309"/>
              <a:ext cx="26189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2-K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510200" y="2766965"/>
            <a:ext cx="2991200" cy="2304300"/>
            <a:chOff x="117233" y="5071265"/>
            <a:chExt cx="3168184" cy="1663143"/>
          </a:xfrm>
        </p:grpSpPr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7233" y="5071265"/>
              <a:ext cx="3168184" cy="16631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6" name="TextBox 85"/>
            <p:cNvSpPr txBox="1"/>
            <p:nvPr/>
          </p:nvSpPr>
          <p:spPr>
            <a:xfrm>
              <a:off x="367419" y="5342393"/>
              <a:ext cx="27526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2-K Y321A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0955" y="5532125"/>
            <a:ext cx="2275874" cy="2000666"/>
            <a:chOff x="5032031" y="3265133"/>
            <a:chExt cx="2275874" cy="2866754"/>
          </a:xfrm>
        </p:grpSpPr>
        <p:pic>
          <p:nvPicPr>
            <p:cNvPr id="13" name="Picture 12" descr="h-2k p8.tiff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 xmlns="">
                    <a14:imgLayer r:embed="rId6">
                      <a14:imgEffect>
                        <a14:brightnessContrast bright="2000" contrast="4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/>
                </a:ext>
              </a:extLst>
            </a:blip>
            <a:srcRect l="47538" t="49402" r="41580" b="10587"/>
            <a:stretch/>
          </p:blipFill>
          <p:spPr>
            <a:xfrm flipV="1">
              <a:off x="5614344" y="3265133"/>
              <a:ext cx="723457" cy="286675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TextBox 23"/>
            <p:cNvSpPr txBox="1"/>
            <p:nvPr/>
          </p:nvSpPr>
          <p:spPr>
            <a:xfrm>
              <a:off x="5147246" y="3770057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147246" y="3964080"/>
              <a:ext cx="603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147246" y="4155270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209182" y="4349294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224056" y="4540484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224056" y="4734507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224056" y="4980728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224056" y="5145820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224056" y="5339843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224056" y="5534370"/>
              <a:ext cx="437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405016" y="4853718"/>
              <a:ext cx="9028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5486291" y="4131221"/>
              <a:ext cx="9134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5486291" y="4310026"/>
              <a:ext cx="9134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5486291" y="4508357"/>
              <a:ext cx="909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5486291" y="4698158"/>
              <a:ext cx="9134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5486291" y="4883481"/>
              <a:ext cx="9091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5486291" y="5131178"/>
              <a:ext cx="9134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5486291" y="5310988"/>
              <a:ext cx="9134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5486291" y="5501795"/>
              <a:ext cx="90914" cy="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5486291" y="5657123"/>
              <a:ext cx="9134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5486291" y="3959765"/>
              <a:ext cx="8077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Arrow Connector 102"/>
            <p:cNvCxnSpPr/>
            <p:nvPr/>
          </p:nvCxnSpPr>
          <p:spPr>
            <a:xfrm>
              <a:off x="5032031" y="4993358"/>
              <a:ext cx="249404" cy="0"/>
            </a:xfrm>
            <a:prstGeom prst="straightConnector1">
              <a:avLst/>
            </a:prstGeom>
            <a:ln w="635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" name="TextBox 89"/>
          <p:cNvSpPr txBox="1"/>
          <p:nvPr/>
        </p:nvSpPr>
        <p:spPr>
          <a:xfrm>
            <a:off x="1508750" y="51864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321604" y="25325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1104564" y="5724150"/>
            <a:ext cx="3246156" cy="2033109"/>
            <a:chOff x="1124700" y="6120264"/>
            <a:chExt cx="3246156" cy="2033109"/>
          </a:xfrm>
        </p:grpSpPr>
        <p:sp>
          <p:nvSpPr>
            <p:cNvPr id="61" name="TextBox 60"/>
            <p:cNvSpPr txBox="1"/>
            <p:nvPr/>
          </p:nvSpPr>
          <p:spPr>
            <a:xfrm>
              <a:off x="3095079" y="7374394"/>
              <a:ext cx="395698" cy="4396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551217" y="7359891"/>
              <a:ext cx="395698" cy="4396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885381" y="7375565"/>
              <a:ext cx="485475" cy="7778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 onl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Right Triangle 63"/>
            <p:cNvSpPr/>
            <p:nvPr/>
          </p:nvSpPr>
          <p:spPr>
            <a:xfrm flipH="1">
              <a:off x="2276839" y="7759615"/>
              <a:ext cx="1608541" cy="140197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65" name="Picture 9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76840" y="6135745"/>
              <a:ext cx="361588" cy="1250861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6" name="Picture 10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86687" y="6138776"/>
              <a:ext cx="364848" cy="1247829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7" name="Picture 11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0829" y="6135745"/>
              <a:ext cx="365734" cy="1250861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7" name="Picture 12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17429" y="6128163"/>
              <a:ext cx="367952" cy="1258442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9" name="Picture 13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33753" y="6120264"/>
              <a:ext cx="370261" cy="1266342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1" name="TextBox 80"/>
            <p:cNvSpPr txBox="1"/>
            <p:nvPr/>
          </p:nvSpPr>
          <p:spPr>
            <a:xfrm>
              <a:off x="2672189" y="7388904"/>
              <a:ext cx="395698" cy="379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247011" y="7381097"/>
              <a:ext cx="395698" cy="3794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276839" y="7874830"/>
              <a:ext cx="1608541" cy="270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2-K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 rot="16200000">
              <a:off x="1086063" y="6501933"/>
              <a:ext cx="901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GI-1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727790" y="6192785"/>
              <a:ext cx="551735" cy="270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Z1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725104" y="6418061"/>
              <a:ext cx="551735" cy="270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Z2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725103" y="6639069"/>
              <a:ext cx="551735" cy="270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Z3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586619" y="6843488"/>
              <a:ext cx="674805" cy="270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Z4+5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124700" y="7075558"/>
              <a:ext cx="11367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 H2-K </a:t>
              </a:r>
            </a:p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+ control)</a:t>
              </a:r>
            </a:p>
          </p:txBody>
        </p:sp>
        <p:cxnSp>
          <p:nvCxnSpPr>
            <p:cNvPr id="97" name="Straight Connector 96"/>
            <p:cNvCxnSpPr/>
            <p:nvPr/>
          </p:nvCxnSpPr>
          <p:spPr>
            <a:xfrm>
              <a:off x="1645528" y="6165361"/>
              <a:ext cx="0" cy="9141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/>
            <p:nvPr/>
          </p:nvCxnSpPr>
          <p:spPr>
            <a:xfrm flipH="1">
              <a:off x="2276839" y="7074820"/>
              <a:ext cx="2027175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4338734" y="5271813"/>
            <a:ext cx="2573136" cy="2679827"/>
            <a:chOff x="7593121" y="4859427"/>
            <a:chExt cx="3555604" cy="2693101"/>
          </a:xfrm>
        </p:grpSpPr>
        <p:pic>
          <p:nvPicPr>
            <p:cNvPr id="100" name="Picture 14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82167" y="4882979"/>
              <a:ext cx="2463492" cy="2079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1" name="TextBox 100"/>
            <p:cNvSpPr txBox="1"/>
            <p:nvPr/>
          </p:nvSpPr>
          <p:spPr>
            <a:xfrm>
              <a:off x="10294176" y="6858585"/>
              <a:ext cx="854549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/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GST only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 rot="16200000">
              <a:off x="6694688" y="5761889"/>
              <a:ext cx="2349746" cy="552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nding to MAGI-1 PDZ 1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ckground subtracted density, AU)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9869626" y="6858585"/>
              <a:ext cx="6214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  <a:p>
              <a:pPr algn="ctr"/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8649071" y="7306307"/>
              <a:ext cx="17457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2-K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9402716" y="6858585"/>
              <a:ext cx="7322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8861325" y="6858585"/>
              <a:ext cx="730556" cy="4020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8506881" y="6858585"/>
              <a:ext cx="562347" cy="4020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Straight Connector 108"/>
            <p:cNvCxnSpPr/>
            <p:nvPr/>
          </p:nvCxnSpPr>
          <p:spPr>
            <a:xfrm flipH="1">
              <a:off x="8629713" y="7305852"/>
              <a:ext cx="1754657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8012224" y="4859427"/>
              <a:ext cx="610448" cy="247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8066810" y="5167003"/>
              <a:ext cx="6052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8099589" y="5481411"/>
              <a:ext cx="5513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8087232" y="5796153"/>
              <a:ext cx="5654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8012224" y="6117883"/>
              <a:ext cx="621618" cy="247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8012224" y="6442611"/>
              <a:ext cx="615734" cy="247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8226375" y="6748847"/>
              <a:ext cx="3956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7" name="TextBox 116"/>
          <p:cNvSpPr txBox="1"/>
          <p:nvPr/>
        </p:nvSpPr>
        <p:spPr>
          <a:xfrm>
            <a:off x="4273910" y="518648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587030" y="5324309"/>
            <a:ext cx="7526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H2-K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-20827" y="253653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526002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74</TotalTime>
  <Words>189</Words>
  <Application>Microsoft Office PowerPoint</Application>
  <PresentationFormat>On-screen Show (4:3)</PresentationFormat>
  <Paragraphs>8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Princeto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ulanger, Lisa M.</dc:creator>
  <cp:lastModifiedBy>escusana</cp:lastModifiedBy>
  <cp:revision>62</cp:revision>
  <dcterms:created xsi:type="dcterms:W3CDTF">2015-10-27T22:53:08Z</dcterms:created>
  <dcterms:modified xsi:type="dcterms:W3CDTF">2016-05-31T21:55:01Z</dcterms:modified>
</cp:coreProperties>
</file>